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15CCC0-2096-466E-87A3-F5E3FE866BF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D4420F-0ADA-4A05-B935-B8FDD596AB3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A13E2B-FA9D-4EB9-85E1-2596F4D6EA3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E22C5E-C92A-46CA-8D09-AC8F0DC7764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0C3C9E-C87C-4DF8-A875-03F7D657CFE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7A4967-D3C9-4F2F-90A2-FBF8F82F635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53A5DE-0470-432C-83E9-3FE388AEF65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900948-A38E-450E-8B7D-E51A9C6D438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01BBB7-B161-4CE2-9B83-8121E7C40DE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0DD47A-2B63-4201-96F0-2CD89D447FF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6A7AA5-B929-4820-B3BB-D62B75A6FEF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B36C5D-CFCB-41F9-AC39-9F7442ADBDE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4FE6884-D6A5-4A1F-B631-2C7A0A8002B3}" type="slidenum">
              <a:rPr b="0" lang="fr-FR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2" descr=""/>
          <p:cNvPicPr/>
          <p:nvPr/>
        </p:nvPicPr>
        <p:blipFill>
          <a:blip r:embed="rId1"/>
          <a:stretch/>
        </p:blipFill>
        <p:spPr>
          <a:xfrm>
            <a:off x="1233360" y="96840"/>
            <a:ext cx="6677280" cy="6664320"/>
          </a:xfrm>
          <a:prstGeom prst="rect">
            <a:avLst/>
          </a:prstGeom>
          <a:ln w="0">
            <a:noFill/>
          </a:ln>
        </p:spPr>
      </p:pic>
      <p:sp>
        <p:nvSpPr>
          <p:cNvPr id="42" name="ZoneTexte 3"/>
          <p:cNvSpPr/>
          <p:nvPr/>
        </p:nvSpPr>
        <p:spPr>
          <a:xfrm>
            <a:off x="763920" y="142920"/>
            <a:ext cx="7579800" cy="42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Cambria"/>
              </a:rPr>
              <a:t>Figure S3. Network of 24 outcome domains defined as component outcomes of the success/failure composite outcome 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Cambria"/>
              </a:rPr>
              <a:t>in the “Methods” section of 47 RCTs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8-10T17:41:58Z</dcterms:created>
  <dc:creator>Amar</dc:creator>
  <dc:description/>
  <dc:language>en-US</dc:language>
  <cp:lastModifiedBy>Amar</cp:lastModifiedBy>
  <dcterms:modified xsi:type="dcterms:W3CDTF">2012-09-12T08:51:28Z</dcterms:modified>
  <cp:revision>3</cp:revision>
  <dc:subject/>
  <dc:title>Présentation PowerPoint</dc:title>
</cp:coreProperties>
</file>